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64" autoAdjust="0"/>
  </p:normalViewPr>
  <p:slideViewPr>
    <p:cSldViewPr>
      <p:cViewPr varScale="1">
        <p:scale>
          <a:sx n="110" d="100"/>
          <a:sy n="110" d="100"/>
        </p:scale>
        <p:origin x="1038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B6C98D-F2CA-4142-88E4-F110C69551B9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5B933C-D3C1-4C98-A9B3-C5B01853F7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2794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7411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zh-CN" smtClean="0"/>
              <a:t>Dose response in rats. Leukocytes in peripheral blood were counted by hemocytometer. A, WBC=white blood cell; B, NE=Neutrophil; C, EO=Eosinophils; D, BA=Basophils; E, MO=Monocyte; F, LY=Lymphocyte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ABAB1ECF-524C-4AA4-84A5-43057646C809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4456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50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8854743"/>
              </p:ext>
            </p:extLst>
          </p:nvPr>
        </p:nvGraphicFramePr>
        <p:xfrm>
          <a:off x="438869" y="1139693"/>
          <a:ext cx="2620963" cy="2017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0" name="Graph" r:id="rId4" imgW="3876480" imgH="2986560" progId="Origin50.Graph">
                  <p:embed/>
                </p:oleObj>
              </mc:Choice>
              <mc:Fallback>
                <p:oleObj name="Graph" r:id="rId4" imgW="3876480" imgH="2986560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8869" y="1139693"/>
                        <a:ext cx="2620963" cy="20177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1" name="TextBox 33"/>
          <p:cNvSpPr txBox="1">
            <a:spLocks noChangeArrowheads="1"/>
          </p:cNvSpPr>
          <p:nvPr/>
        </p:nvSpPr>
        <p:spPr bwMode="auto">
          <a:xfrm>
            <a:off x="430138" y="716888"/>
            <a:ext cx="356178" cy="400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>
              <a:defRPr sz="65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 sz="57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 sz="48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52" name="TextBox 34"/>
          <p:cNvSpPr txBox="1">
            <a:spLocks noChangeArrowheads="1"/>
          </p:cNvSpPr>
          <p:nvPr/>
        </p:nvSpPr>
        <p:spPr bwMode="auto">
          <a:xfrm>
            <a:off x="3238732" y="716888"/>
            <a:ext cx="356178" cy="400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>
              <a:defRPr sz="65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 sz="57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 sz="48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053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815337"/>
              </p:ext>
            </p:extLst>
          </p:nvPr>
        </p:nvGraphicFramePr>
        <p:xfrm>
          <a:off x="3248025" y="1139693"/>
          <a:ext cx="2620963" cy="2017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1" name="Graph" r:id="rId6" imgW="3876480" imgH="2986560" progId="Origin50.Graph">
                  <p:embed/>
                </p:oleObj>
              </mc:Choice>
              <mc:Fallback>
                <p:oleObj name="Graph" r:id="rId6" imgW="3876480" imgH="2986560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48025" y="1139693"/>
                        <a:ext cx="2620963" cy="20177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4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5971304"/>
              </p:ext>
            </p:extLst>
          </p:nvPr>
        </p:nvGraphicFramePr>
        <p:xfrm>
          <a:off x="6209806" y="3571527"/>
          <a:ext cx="2619375" cy="2017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2" name="Graph" r:id="rId8" imgW="3876480" imgH="2986560" progId="Origin50.Graph">
                  <p:embed/>
                </p:oleObj>
              </mc:Choice>
              <mc:Fallback>
                <p:oleObj name="Graph" r:id="rId8" imgW="3876480" imgH="2986560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209806" y="3571527"/>
                        <a:ext cx="2619375" cy="20177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5" name="TextBox 34"/>
          <p:cNvSpPr txBox="1">
            <a:spLocks noChangeArrowheads="1"/>
          </p:cNvSpPr>
          <p:nvPr/>
        </p:nvSpPr>
        <p:spPr bwMode="auto">
          <a:xfrm>
            <a:off x="6011613" y="709134"/>
            <a:ext cx="370604" cy="400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>
              <a:defRPr sz="65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 sz="57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 sz="48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056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2575442"/>
              </p:ext>
            </p:extLst>
          </p:nvPr>
        </p:nvGraphicFramePr>
        <p:xfrm>
          <a:off x="3236913" y="3533329"/>
          <a:ext cx="2620962" cy="2017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3" name="Graph" r:id="rId10" imgW="3876480" imgH="2986560" progId="Origin50.Graph">
                  <p:embed/>
                </p:oleObj>
              </mc:Choice>
              <mc:Fallback>
                <p:oleObj name="Graph" r:id="rId10" imgW="3876480" imgH="2986560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36913" y="3533329"/>
                        <a:ext cx="2620962" cy="20177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7" name="TextBox 33"/>
          <p:cNvSpPr txBox="1">
            <a:spLocks noChangeArrowheads="1"/>
          </p:cNvSpPr>
          <p:nvPr/>
        </p:nvSpPr>
        <p:spPr bwMode="auto">
          <a:xfrm>
            <a:off x="404742" y="3244921"/>
            <a:ext cx="370604" cy="400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>
              <a:defRPr sz="65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 sz="57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 sz="48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2058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8439612"/>
              </p:ext>
            </p:extLst>
          </p:nvPr>
        </p:nvGraphicFramePr>
        <p:xfrm>
          <a:off x="6148388" y="1095045"/>
          <a:ext cx="2620962" cy="2017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4" name="Graph" r:id="rId12" imgW="3876480" imgH="2986560" progId="Origin50.Graph">
                  <p:embed/>
                </p:oleObj>
              </mc:Choice>
              <mc:Fallback>
                <p:oleObj name="Graph" r:id="rId12" imgW="3876480" imgH="2986560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148388" y="1095045"/>
                        <a:ext cx="2620962" cy="20177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9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1696581"/>
              </p:ext>
            </p:extLst>
          </p:nvPr>
        </p:nvGraphicFramePr>
        <p:xfrm>
          <a:off x="303213" y="3533329"/>
          <a:ext cx="2619375" cy="2017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45" name="Graph" r:id="rId14" imgW="3876480" imgH="2986560" progId="Origin50.Graph">
                  <p:embed/>
                </p:oleObj>
              </mc:Choice>
              <mc:Fallback>
                <p:oleObj name="Graph" r:id="rId14" imgW="3876480" imgH="2986560" progId="Origin50.Graph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3213" y="3533329"/>
                        <a:ext cx="2619375" cy="20177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60" name="TextBox 33"/>
          <p:cNvSpPr txBox="1">
            <a:spLocks noChangeArrowheads="1"/>
          </p:cNvSpPr>
          <p:nvPr/>
        </p:nvSpPr>
        <p:spPr bwMode="auto">
          <a:xfrm>
            <a:off x="3256191" y="3229414"/>
            <a:ext cx="356178" cy="400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>
              <a:defRPr sz="65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 sz="57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 sz="48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061" name="TextBox 33"/>
          <p:cNvSpPr txBox="1">
            <a:spLocks noChangeArrowheads="1"/>
          </p:cNvSpPr>
          <p:nvPr/>
        </p:nvSpPr>
        <p:spPr bwMode="auto">
          <a:xfrm>
            <a:off x="5998915" y="3229414"/>
            <a:ext cx="341750" cy="400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>
              <a:defRPr sz="65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 sz="57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 sz="48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062" name="TextBox 33"/>
          <p:cNvSpPr txBox="1">
            <a:spLocks noChangeArrowheads="1"/>
          </p:cNvSpPr>
          <p:nvPr/>
        </p:nvSpPr>
        <p:spPr bwMode="auto">
          <a:xfrm>
            <a:off x="66814" y="97474"/>
            <a:ext cx="1322788" cy="5232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>
              <a:defRPr sz="65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 sz="57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 sz="48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 sz="4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Aft>
                <a:spcPct val="0"/>
              </a:spcAft>
              <a:buFont typeface="Arial" charset="0"/>
              <a:buChar char="»"/>
              <a:defRPr sz="4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zh-CN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. S1</a:t>
            </a:r>
            <a:endParaRPr lang="en-US" altLang="zh-CN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76273" y="5517232"/>
            <a:ext cx="8860223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</a:t>
            </a:r>
            <a:r>
              <a:rPr lang="en-US" sz="14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S1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The </a:t>
            </a:r>
            <a:r>
              <a:rPr lang="en-US" sz="14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ose 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ffect of </a:t>
            </a:r>
            <a:r>
              <a:rPr lang="en-US" sz="14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2G 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n </a:t>
            </a:r>
            <a:r>
              <a:rPr lang="en-US" sz="14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hite blood 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ells mobilization in </a:t>
            </a:r>
            <a:r>
              <a:rPr lang="en-US" sz="14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tact rats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1 h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fter injection,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2G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ose-dependently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bilized increased peripheral white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lood cells 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WBC),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eutrophils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NE),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osinophils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EO) and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asophils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Basophils) within the dose range from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0.197 to 3.15 </a:t>
            </a:r>
            <a:r>
              <a:rPr lang="en-US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ol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kg body weight, while there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o significant changes for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onocytes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MO) within the above mention dose range. For Lymphocyte 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LY),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nly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ignificant increased at 3.15 </a:t>
            </a:r>
            <a:r>
              <a:rPr lang="en-US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μmol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/kg body weight. </a:t>
            </a:r>
            <a:r>
              <a:rPr lang="en-US" sz="14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=5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 least for each group. *: p &lt; 0.05 vs. PBS</a:t>
            </a:r>
            <a:endParaRPr lang="en-US" sz="1400" kern="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2696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0</TotalTime>
  <Words>168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SimSun</vt:lpstr>
      <vt:lpstr>Arial</vt:lpstr>
      <vt:lpstr>Calibri</vt:lpstr>
      <vt:lpstr>Times New Roman</vt:lpstr>
      <vt:lpstr>Office 主题</vt:lpstr>
      <vt:lpstr>Origin Graph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Tan,Yi</cp:lastModifiedBy>
  <cp:revision>17</cp:revision>
  <dcterms:created xsi:type="dcterms:W3CDTF">2014-03-03T23:03:02Z</dcterms:created>
  <dcterms:modified xsi:type="dcterms:W3CDTF">2017-01-23T20:51:51Z</dcterms:modified>
</cp:coreProperties>
</file>